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2390" y="-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C20D1F-CC7C-4AEF-80B6-BF4068ACBE7B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792D00-D1F3-427F-B84F-08B371C7A26D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26" name="Object 2"/>
          <p:cNvGraphicFramePr>
            <a:graphicFrameLocks noChangeAspect="1"/>
          </p:cNvGraphicFramePr>
          <p:nvPr/>
        </p:nvGraphicFramePr>
        <p:xfrm>
          <a:off x="1214422" y="357158"/>
          <a:ext cx="3573463" cy="1990725"/>
        </p:xfrm>
        <a:graphic>
          <a:graphicData uri="http://schemas.openxmlformats.org/presentationml/2006/ole">
            <p:oleObj spid="_x0000_s1026" name="Prism Project" r:id="rId3" imgW="4392000" imgH="2448000" progId="Prism5.Document">
              <p:embed/>
            </p:oleObj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285728" y="2428860"/>
            <a:ext cx="64293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1. </a:t>
            </a:r>
            <a:r>
              <a:rPr lang="en-US" sz="1200" i="1" smtClean="0"/>
              <a:t>FOXJ1</a:t>
            </a:r>
            <a:r>
              <a:rPr lang="en-US" sz="1200" smtClean="0"/>
              <a:t> </a:t>
            </a:r>
            <a:r>
              <a:rPr lang="en-US" sz="1200" dirty="0" smtClean="0"/>
              <a:t>mRNA expression in primary bronchial epithelial cells (PBEC) after air-liquid interface (ALI) culture for 14, 21 and 28 days. PBEC from control subjects 1-6 (Table 1, n=6) were cultured at ALI with IL-13 stimulation and mRNA expression of </a:t>
            </a:r>
            <a:r>
              <a:rPr lang="en-US" sz="1200" i="1" dirty="0" smtClean="0"/>
              <a:t>FOXJ1</a:t>
            </a:r>
            <a:r>
              <a:rPr lang="en-US" sz="1200" dirty="0" smtClean="0"/>
              <a:t> was analyzed by real-time quantitative PCR at four different time points. Medians are indicated. Significance was tested by the </a:t>
            </a:r>
            <a:r>
              <a:rPr lang="en-US" sz="1200" dirty="0" err="1" smtClean="0"/>
              <a:t>Kruskal</a:t>
            </a:r>
            <a:r>
              <a:rPr lang="en-US" sz="1200" dirty="0" smtClean="0"/>
              <a:t>-Wallis nonparametric test with Dunn’s posttest data. ns = not significant, and **p&lt;0.01; data from day 14, 21, and 28 were compared to day 0.</a:t>
            </a:r>
            <a:endParaRPr lang="nl-NL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5</Words>
  <Application>Microsoft Office PowerPoint</Application>
  <PresentationFormat>Diavoorstelling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3</cp:revision>
  <dcterms:created xsi:type="dcterms:W3CDTF">2016-12-16T16:46:35Z</dcterms:created>
  <dcterms:modified xsi:type="dcterms:W3CDTF">2016-12-16T17:38:58Z</dcterms:modified>
</cp:coreProperties>
</file>